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98" d="100"/>
          <a:sy n="98" d="100"/>
        </p:scale>
        <p:origin x="54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C315C4-ACB9-58FE-12BB-7F32E63F11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759ED04-F8F7-FF31-F51E-456A45BC68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078B1C-AE6E-9730-A366-11BFF98ED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596475-2F47-A2EB-BFF8-0C4AACCDE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B3D9C6-3368-50F8-F94A-518A7EF8D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0585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69A6D1-5875-FD13-3758-CE1F4EC618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C5C8244-6765-EBCC-BA02-D779953CEB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99B9E5-E274-0648-EE40-41C4AC971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17EA53-0F05-85CA-4BED-4436D0C4A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0A0DB8-4537-9467-1935-CE9147C70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0928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EF34682-7049-1162-51B8-E49E285453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576D57-C0C8-833D-F5F6-97558D4CEA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B29446F-15CA-E634-B1C8-28EF4D000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3EC99B-ADCE-774C-F7E7-CDDD0E253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8C3551-7A40-D735-8AF1-FBBA99BF2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240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4D59FA-29EB-51C5-118D-7039AC3478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B7E02E1-30EF-8CF0-5587-C4B3F1F2ED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1AAB7C7-70CF-6E01-18DE-CFDF4BB3D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00E15F-55B8-6D39-023C-333D7C723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DFEEEA2-16DE-430F-E2F9-18850C846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9081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F35B5E-6398-D959-A10D-AF9D45902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0159E8-A137-B6C0-7394-BA21923394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9BC378-5FCB-8EDC-3066-7BDD8AD10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15B7AF-7F13-25F4-5E44-B2473FF4E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1E3D1B-1DE7-D9D7-92BC-458DAC864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663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51F3F9-131A-1F34-ECB1-AF4FE91996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1484DE4-4EE4-AB5D-E7C2-08395B7CBD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ED88960-9B8E-F852-9217-9618716E26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E454BC4-D128-328B-D0E0-43DFD3358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04D1693-B707-08CD-82FE-EF6014A26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67E4A8D-DCBF-510D-2FB0-46EB7AB60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623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3773DD-B7BD-E350-65DD-080ADDFCAE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DAAE1DA-7820-869D-2447-FD883536D5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C288FC7-0AB7-A7BE-EF9E-5D1BD82684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90AEACF-47A2-D4A1-5D94-5588564231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6E68C72-CE1F-FD19-F303-8E3E8C3739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3657B0E-F329-F9BC-F2EE-FAE4DDB3D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0C439C3-BB3E-DF8F-44BF-92F6796A4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B988615-2A68-D0EB-B0FA-A0137CBCB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005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0D9017-41FE-A1F5-F876-00B4B6965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870CF45-5314-30EE-9165-B1F4286FE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DB81858-ED5C-0A86-6161-FE4E7E540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5585A67-4B06-49E3-4C45-5040A7AE5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325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BCDD573-AF7E-7726-DA24-5B0DE1458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C2B7FE9-155C-04DB-E145-E6EEB9CDB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5A711E8-5DDA-7056-51D2-1F5951E86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4056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0AECAD-C0DA-E0D2-535D-CE99F2B253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BF2843-4739-F29F-D37D-32435A3423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39BEF69-1947-51E2-AAA9-E3A104F2EB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998E6D-B412-CDD2-F9D7-AA63CE37A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07BD003-2EA6-00B9-4170-CDB1C4F2A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743D89-0B46-0E58-0834-BE9D1E0E9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5260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5795B1-3947-0062-F46F-CB6AB79EB8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A0AE041-3B8E-F911-17FA-C80743413E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8F0E4FC-9D51-BD0A-2334-18F4B3DAEE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C413CA9-70BC-0741-C45C-1E43C41C2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373A5F-9F8D-7F4E-C6F3-1CA1399AF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25DF36E-ECA0-BF57-A5CE-528A649E3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7743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BA598FC-3DD2-5BDF-1926-BEBAF51C6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02BFD1-A21E-0E51-80A3-4F7556ED94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6FD2A6-599A-DAAC-A812-31CA5B21DF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8078A-408F-43A5-9687-79C1FB77FB83}" type="datetimeFigureOut">
              <a:rPr kumimoji="1" lang="ja-JP" altLang="en-US" smtClean="0"/>
              <a:t>2022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05AC21-58D1-D3F9-5099-DF5E2C8145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47A083-DFFC-DF5F-6582-ABCED73826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2C456-DC91-4DBF-87E5-614AEB0412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076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wmv"/><Relationship Id="rId7" Type="http://schemas.openxmlformats.org/officeDocument/2006/relationships/image" Target="../media/image2.png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wmv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追跡課題">
            <a:hlinkClick r:id="" action="ppaction://media"/>
            <a:extLst>
              <a:ext uri="{FF2B5EF4-FFF2-40B4-BE49-F238E27FC236}">
                <a16:creationId xmlns:a16="http://schemas.microsoft.com/office/drawing/2014/main" id="{B400012F-90D7-9C58-3131-1E8C96A2A89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014877" y="862677"/>
            <a:ext cx="4976975" cy="2972261"/>
          </a:xfrm>
          <a:prstGeom prst="rect">
            <a:avLst/>
          </a:prstGeom>
        </p:spPr>
      </p:pic>
      <p:pic>
        <p:nvPicPr>
          <p:cNvPr id="5" name="突発課題">
            <a:hlinkClick r:id="" action="ppaction://media"/>
            <a:extLst>
              <a:ext uri="{FF2B5EF4-FFF2-40B4-BE49-F238E27FC236}">
                <a16:creationId xmlns:a16="http://schemas.microsoft.com/office/drawing/2014/main" id="{7850CE55-30F4-C75D-F2B9-4C022CB3DE6F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483244" y="862677"/>
            <a:ext cx="5010991" cy="2924641"/>
          </a:xfrm>
          <a:prstGeom prst="rect">
            <a:avLst/>
          </a:prstGeom>
        </p:spPr>
      </p:pic>
      <p:pic>
        <p:nvPicPr>
          <p:cNvPr id="6" name="Picture 2" descr="視力検査の前に知っておきたい「視力の数値」のこと | メガネハット（株式会社アーバン）">
            <a:extLst>
              <a:ext uri="{FF2B5EF4-FFF2-40B4-BE49-F238E27FC236}">
                <a16:creationId xmlns:a16="http://schemas.microsoft.com/office/drawing/2014/main" id="{A5010CBE-E17D-F420-DF9B-EE2949306D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1847" y="3053402"/>
            <a:ext cx="375598" cy="3755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7F542F88-6242-A607-BC02-5B5A22F15E4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06874" y="2393900"/>
            <a:ext cx="375598" cy="37559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A217E5F-52F3-BB6D-1F95-16086D00640A}"/>
              </a:ext>
            </a:extLst>
          </p:cNvPr>
          <p:cNvSpPr txBox="1"/>
          <p:nvPr/>
        </p:nvSpPr>
        <p:spPr>
          <a:xfrm>
            <a:off x="1091481" y="2732937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07A7A4D-6CD8-0623-E72E-BB3EA9DB1DA7}"/>
              </a:ext>
            </a:extLst>
          </p:cNvPr>
          <p:cNvSpPr txBox="1"/>
          <p:nvPr/>
        </p:nvSpPr>
        <p:spPr>
          <a:xfrm>
            <a:off x="1086136" y="3417333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DA79075-5F9A-B2E3-0FB9-51181976CEDD}"/>
              </a:ext>
            </a:extLst>
          </p:cNvPr>
          <p:cNvSpPr txBox="1"/>
          <p:nvPr/>
        </p:nvSpPr>
        <p:spPr>
          <a:xfrm>
            <a:off x="1103857" y="1023878"/>
            <a:ext cx="5052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kumimoji="1" lang="ja-JP" altLang="en-US" sz="2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5115397-2BDB-F6F1-4B4B-1262158CEBDF}"/>
              </a:ext>
            </a:extLst>
          </p:cNvPr>
          <p:cNvSpPr txBox="1"/>
          <p:nvPr/>
        </p:nvSpPr>
        <p:spPr>
          <a:xfrm>
            <a:off x="6656323" y="979490"/>
            <a:ext cx="5245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kumimoji="1" lang="ja-JP" altLang="en-US" sz="2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2" descr="視力検査の前に知っておきたい「視力の数値」のこと | メガネハット（株式会社アーバン）">
            <a:extLst>
              <a:ext uri="{FF2B5EF4-FFF2-40B4-BE49-F238E27FC236}">
                <a16:creationId xmlns:a16="http://schemas.microsoft.com/office/drawing/2014/main" id="{D20F3D64-007A-2867-D150-653C45FD94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82444" y="3116904"/>
            <a:ext cx="375598" cy="3755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3664C6B2-604D-8B76-6A36-4F97BF9A0B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97471" y="2457402"/>
            <a:ext cx="375598" cy="375598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81ADF66-19D9-EF60-118C-89986E3F1929}"/>
              </a:ext>
            </a:extLst>
          </p:cNvPr>
          <p:cNvSpPr txBox="1"/>
          <p:nvPr/>
        </p:nvSpPr>
        <p:spPr>
          <a:xfrm>
            <a:off x="6582078" y="2796439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al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5B4F01F-C412-7DA3-9C7F-0E9FF5A60A30}"/>
              </a:ext>
            </a:extLst>
          </p:cNvPr>
          <p:cNvSpPr txBox="1"/>
          <p:nvPr/>
        </p:nvSpPr>
        <p:spPr>
          <a:xfrm>
            <a:off x="6576733" y="3480835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kumimoji="1" lang="ja-JP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93D55AE-8F4E-4F21-0CB8-CFE23C8F0324}"/>
              </a:ext>
            </a:extLst>
          </p:cNvPr>
          <p:cNvSpPr txBox="1"/>
          <p:nvPr/>
        </p:nvSpPr>
        <p:spPr>
          <a:xfrm>
            <a:off x="857990" y="3996139"/>
            <a:ext cx="1063624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 Dynamic visual cognition (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VC) t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st has two types of task. a) </a:t>
            </a:r>
            <a:r>
              <a:rPr lang="en-GB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 tracking motion task to</a:t>
            </a:r>
          </a:p>
          <a:p>
            <a:r>
              <a:rPr lang="en-GB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ollow dynamic indicators mainly using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smooth pursuit movements. b)</a:t>
            </a:r>
            <a:r>
              <a:rPr lang="en-GB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 sudden motion task to detect jumping </a:t>
            </a:r>
          </a:p>
          <a:p>
            <a:r>
              <a:rPr lang="en-GB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indicators mainly using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saccadic eye movements.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20916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4</TotalTime>
  <Words>56</Words>
  <Application>Microsoft Office PowerPoint</Application>
  <PresentationFormat>ワイド画面</PresentationFormat>
  <Paragraphs>9</Paragraphs>
  <Slides>1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朴 啓彰</dc:creator>
  <cp:lastModifiedBy>朴 啓彰</cp:lastModifiedBy>
  <cp:revision>1</cp:revision>
  <dcterms:created xsi:type="dcterms:W3CDTF">2022-05-22T09:37:55Z</dcterms:created>
  <dcterms:modified xsi:type="dcterms:W3CDTF">2022-05-23T02:22:30Z</dcterms:modified>
</cp:coreProperties>
</file>